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jpeg" ContentType="image/jpeg"/>
  <Override PartName="/ppt/media/image8.png" ContentType="image/png"/>
  <Override PartName="/ppt/media/image7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785CC7-8394-4249-983F-408A52F5CD9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6B4559-7C86-4CA9-9BC6-2E24440C46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521E3D-FE11-41EC-B6CD-F2C18E27B8B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F47232-CCA1-4980-B39E-9EFC54465C5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FFB8EE-DEAF-45CB-A2A4-BA2B443383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1E5C12-4067-49E5-A878-C5C9284B29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9938A0-B772-4D7D-B897-B9C3E6DBF9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40E7D8-C60D-4D44-AE6E-03502A8D9C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E61681-0538-4C7A-9DA0-73D706424A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C741B9-E297-4998-94B7-648F165483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3D4ECD-9AC3-4E08-8BC2-C986114668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E7989E-7584-44FE-BCD4-441BA2BCA6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BC97481-9F71-42BD-AA25-8625B7770561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o 48"/>
          <p:cNvGrpSpPr/>
          <p:nvPr/>
        </p:nvGrpSpPr>
        <p:grpSpPr>
          <a:xfrm>
            <a:off x="838080" y="998640"/>
            <a:ext cx="4953240" cy="2931840"/>
            <a:chOff x="838080" y="998640"/>
            <a:chExt cx="4953240" cy="2931840"/>
          </a:xfrm>
        </p:grpSpPr>
        <p:grpSp>
          <p:nvGrpSpPr>
            <p:cNvPr id="42" name="Gruppo 13"/>
            <p:cNvGrpSpPr/>
            <p:nvPr/>
          </p:nvGrpSpPr>
          <p:grpSpPr>
            <a:xfrm>
              <a:off x="838080" y="998640"/>
              <a:ext cx="4953240" cy="2201040"/>
              <a:chOff x="838080" y="998640"/>
              <a:chExt cx="4953240" cy="2201040"/>
            </a:xfrm>
          </p:grpSpPr>
          <p:pic>
            <p:nvPicPr>
              <p:cNvPr id="43" name="Grafico 5" descr=""/>
              <p:cNvPicPr/>
              <p:nvPr/>
            </p:nvPicPr>
            <p:blipFill>
              <a:blip r:embed="rId1"/>
              <a:stretch/>
            </p:blipFill>
            <p:spPr>
              <a:xfrm>
                <a:off x="932400" y="998640"/>
                <a:ext cx="2127600" cy="19519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4" name="Grafico 6" descr=""/>
              <p:cNvPicPr/>
              <p:nvPr/>
            </p:nvPicPr>
            <p:blipFill>
              <a:blip r:embed="rId2"/>
              <a:stretch/>
            </p:blipFill>
            <p:spPr>
              <a:xfrm>
                <a:off x="3297960" y="1071360"/>
                <a:ext cx="1981080" cy="18241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5" name="Rettangolo 7"/>
              <p:cNvSpPr/>
              <p:nvPr/>
            </p:nvSpPr>
            <p:spPr>
              <a:xfrm>
                <a:off x="838080" y="1907640"/>
                <a:ext cx="4953240" cy="129204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46" name="Grafico 50" descr=""/>
            <p:cNvPicPr/>
            <p:nvPr/>
          </p:nvPicPr>
          <p:blipFill>
            <a:blip r:embed="rId3"/>
            <a:stretch/>
          </p:blipFill>
          <p:spPr>
            <a:xfrm>
              <a:off x="932400" y="1834560"/>
              <a:ext cx="2097000" cy="2095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Grafico 51" descr=""/>
            <p:cNvPicPr/>
            <p:nvPr/>
          </p:nvPicPr>
          <p:blipFill>
            <a:blip r:embed="rId4"/>
            <a:stretch/>
          </p:blipFill>
          <p:spPr>
            <a:xfrm>
              <a:off x="3297960" y="1901520"/>
              <a:ext cx="1956960" cy="19436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8" name="Gruppo 11"/>
            <p:cNvGrpSpPr/>
            <p:nvPr/>
          </p:nvGrpSpPr>
          <p:grpSpPr>
            <a:xfrm>
              <a:off x="1088640" y="1869840"/>
              <a:ext cx="153720" cy="74520"/>
              <a:chOff x="1088640" y="1869840"/>
              <a:chExt cx="153720" cy="74520"/>
            </a:xfrm>
          </p:grpSpPr>
          <p:sp>
            <p:nvSpPr>
              <p:cNvPr id="49" name="Connettore 1 56"/>
              <p:cNvSpPr/>
              <p:nvPr/>
            </p:nvSpPr>
            <p:spPr>
              <a:xfrm flipV="1">
                <a:off x="1088640" y="1869840"/>
                <a:ext cx="144720" cy="46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Connettore 1 57"/>
              <p:cNvSpPr/>
              <p:nvPr/>
            </p:nvSpPr>
            <p:spPr>
              <a:xfrm flipV="1">
                <a:off x="1097640" y="1897560"/>
                <a:ext cx="144720" cy="46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1" name="Gruppo 14"/>
            <p:cNvGrpSpPr/>
            <p:nvPr/>
          </p:nvGrpSpPr>
          <p:grpSpPr>
            <a:xfrm>
              <a:off x="3397680" y="1870560"/>
              <a:ext cx="153720" cy="73080"/>
              <a:chOff x="3397680" y="1870560"/>
              <a:chExt cx="153720" cy="73080"/>
            </a:xfrm>
          </p:grpSpPr>
          <p:sp>
            <p:nvSpPr>
              <p:cNvPr id="52" name="Connettore 1 54"/>
              <p:cNvSpPr/>
              <p:nvPr/>
            </p:nvSpPr>
            <p:spPr>
              <a:xfrm flipV="1">
                <a:off x="3397680" y="1870560"/>
                <a:ext cx="142560" cy="460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Connettore 1 55"/>
              <p:cNvSpPr/>
              <p:nvPr/>
            </p:nvSpPr>
            <p:spPr>
              <a:xfrm flipV="1">
                <a:off x="3409200" y="1897560"/>
                <a:ext cx="142200" cy="460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54" name="CasellaDiTesto 192"/>
          <p:cNvSpPr/>
          <p:nvPr/>
        </p:nvSpPr>
        <p:spPr>
          <a:xfrm>
            <a:off x="4758480" y="25560"/>
            <a:ext cx="208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upplementary Figure 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CasellaDiTesto 1"/>
          <p:cNvSpPr/>
          <p:nvPr/>
        </p:nvSpPr>
        <p:spPr>
          <a:xfrm>
            <a:off x="228600" y="5643720"/>
            <a:ext cx="6324480" cy="298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upplementary Figure 7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xogenous miR-34b/c over-expression does not completely counteract c-Myc stabilization induced by CDDP (2 µg/ml)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valuation of the expression levels of 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 miR-34b and miR-34c, and 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 c-Myc, carried out by qRT-PCR (miRscript kit by Qiagen) and western blot analysis, respectively, in the reported transfectants following CDDP and miR mimic molecule pre-loading. The relative abundance of specific miRs was calculated by normalizing to small nucleolar RNAs using the 2-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ΔΔCt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thod.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1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esults: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 reported in SFXa, miR-34b/c expression goes down in LNCaP cells (Vector) at 2 hrs following drug exposure, to allow c-Myc stimulation in response to stress (as reported in Figure 4b). At 4 hrs time, miR expression starts to rise back to basal levels, suggesting the involvement of post-transcriptional stabilization in the sustained c-Myc induction still observed at 12 hours following CDDP (see Figure 4b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 the untreated USP2a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WT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over-expressing cells (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pUSP2a</a:t>
            </a:r>
            <a:r>
              <a:rPr b="0" lang="it-IT" sz="1000" spc="-1" strike="noStrike" baseline="30000">
                <a:solidFill>
                  <a:srgbClr val="000000"/>
                </a:solidFill>
                <a:latin typeface="Arial"/>
              </a:rPr>
              <a:t>WT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 + miR-Ctr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, miR-34b/c are kept at low levels to allow Myc release and GSH increase. Upon CDDP exposure, miR-34 levels undergo a very small decrease and are thereafter maintained under control by USP2a regulation, up to 24 hours following the drug stimulus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hen pre-loaded with mimic molecules (pUSP2a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WT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 miR-34b/c), USP2a-dependent control on miR-34 expression is reverted, c-Myc expression falls down, but still a limited amount of protein is stimulated by CDDP at 2 hours (SFXb). In the following hours, c-Myc protein induction rapidly decreases by 4 hours time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hese data seem thus to suggest that alternative pathways control the early Myc stimulation triggered by drug in this experimental system, and that, as expected, c-Myc stabilization is not dependent on miR regulation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474"/>
          <p:cNvSpPr/>
          <p:nvPr/>
        </p:nvSpPr>
        <p:spPr>
          <a:xfrm>
            <a:off x="380880" y="498600"/>
            <a:ext cx="336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CasellaDiTesto 16"/>
          <p:cNvSpPr/>
          <p:nvPr/>
        </p:nvSpPr>
        <p:spPr>
          <a:xfrm>
            <a:off x="1598760" y="3809880"/>
            <a:ext cx="835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CDDP (hr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8" name="Gruppo 41"/>
          <p:cNvGrpSpPr/>
          <p:nvPr/>
        </p:nvGrpSpPr>
        <p:grpSpPr>
          <a:xfrm>
            <a:off x="1139040" y="584280"/>
            <a:ext cx="1853640" cy="481680"/>
            <a:chOff x="1139040" y="584280"/>
            <a:chExt cx="1853640" cy="481680"/>
          </a:xfrm>
        </p:grpSpPr>
        <p:grpSp>
          <p:nvGrpSpPr>
            <p:cNvPr id="59" name="Gruppo 39"/>
            <p:cNvGrpSpPr/>
            <p:nvPr/>
          </p:nvGrpSpPr>
          <p:grpSpPr>
            <a:xfrm>
              <a:off x="1662120" y="584280"/>
              <a:ext cx="1330560" cy="481680"/>
              <a:chOff x="1662120" y="584280"/>
              <a:chExt cx="1330560" cy="481680"/>
            </a:xfrm>
          </p:grpSpPr>
          <p:sp>
            <p:nvSpPr>
              <p:cNvPr id="60" name="CasellaDiTesto 212"/>
              <p:cNvSpPr/>
              <p:nvPr/>
            </p:nvSpPr>
            <p:spPr>
              <a:xfrm>
                <a:off x="1697760" y="711720"/>
                <a:ext cx="1294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Wingdings 3"/>
                    <a:ea typeface="Wingdings 3"/>
                  </a:rPr>
                  <a:t></a:t>
                </a: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   </a:t>
                </a: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pUSP2a</a:t>
                </a:r>
                <a:r>
                  <a:rPr b="0" lang="it-IT" sz="800" spc="-1" strike="noStrike" baseline="30000">
                    <a:solidFill>
                      <a:srgbClr val="000000"/>
                    </a:solidFill>
                    <a:latin typeface="Arial"/>
                  </a:rPr>
                  <a:t>WT </a:t>
                </a: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 + </a:t>
                </a:r>
                <a:r>
                  <a:rPr b="0" lang="it-IT" sz="800" spc="-1" strike="noStrike" u="sng">
                    <a:solidFill>
                      <a:srgbClr val="000000"/>
                    </a:solidFill>
                    <a:uFillTx/>
                    <a:latin typeface="Arial"/>
                  </a:rPr>
                  <a:t>miR-34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CasellaDiTesto 213"/>
              <p:cNvSpPr/>
              <p:nvPr/>
            </p:nvSpPr>
            <p:spPr>
              <a:xfrm>
                <a:off x="1662120" y="850320"/>
                <a:ext cx="1326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Wingdings 2"/>
                    <a:ea typeface="Wingdings 2"/>
                  </a:rPr>
                  <a:t></a:t>
                </a: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   </a:t>
                </a: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pUSP2a</a:t>
                </a:r>
                <a:r>
                  <a:rPr b="0" lang="it-IT" sz="800" spc="-1" strike="noStrike" baseline="30000">
                    <a:solidFill>
                      <a:srgbClr val="000000"/>
                    </a:solidFill>
                    <a:latin typeface="Arial"/>
                  </a:rPr>
                  <a:t>WT </a:t>
                </a: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 + miR-Ctr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CasellaDiTesto 211"/>
              <p:cNvSpPr/>
              <p:nvPr/>
            </p:nvSpPr>
            <p:spPr>
              <a:xfrm>
                <a:off x="1665000" y="584280"/>
                <a:ext cx="685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Wingdings"/>
                    <a:ea typeface="Wingdings"/>
                  </a:rPr>
                  <a:t></a:t>
                </a: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   </a:t>
                </a: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Vector 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3" name="CasellaDiTesto 28"/>
            <p:cNvSpPr/>
            <p:nvPr/>
          </p:nvSpPr>
          <p:spPr>
            <a:xfrm>
              <a:off x="1139040" y="689760"/>
              <a:ext cx="508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LNCa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4" name="CasellaDiTesto 30"/>
          <p:cNvSpPr/>
          <p:nvPr/>
        </p:nvSpPr>
        <p:spPr>
          <a:xfrm rot="16200000">
            <a:off x="-42840" y="2167920"/>
            <a:ext cx="179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Relative miR-34b expres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474"/>
          <p:cNvSpPr/>
          <p:nvPr/>
        </p:nvSpPr>
        <p:spPr>
          <a:xfrm>
            <a:off x="306360" y="4114800"/>
            <a:ext cx="336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CasellaDiTesto 17"/>
          <p:cNvSpPr/>
          <p:nvPr/>
        </p:nvSpPr>
        <p:spPr>
          <a:xfrm>
            <a:off x="3891240" y="3809880"/>
            <a:ext cx="835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CDDP (hr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CasellaDiTesto 31"/>
          <p:cNvSpPr/>
          <p:nvPr/>
        </p:nvSpPr>
        <p:spPr>
          <a:xfrm rot="16200000">
            <a:off x="2263320" y="2168280"/>
            <a:ext cx="178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Relative miR-34c expres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8" name="Gruppo 41"/>
          <p:cNvGrpSpPr/>
          <p:nvPr/>
        </p:nvGrpSpPr>
        <p:grpSpPr>
          <a:xfrm>
            <a:off x="3587040" y="582480"/>
            <a:ext cx="1869840" cy="482760"/>
            <a:chOff x="3587040" y="582480"/>
            <a:chExt cx="1869840" cy="482760"/>
          </a:xfrm>
        </p:grpSpPr>
        <p:grpSp>
          <p:nvGrpSpPr>
            <p:cNvPr id="69" name="Gruppo 39"/>
            <p:cNvGrpSpPr/>
            <p:nvPr/>
          </p:nvGrpSpPr>
          <p:grpSpPr>
            <a:xfrm>
              <a:off x="4110480" y="582480"/>
              <a:ext cx="1346400" cy="482760"/>
              <a:chOff x="4110480" y="582480"/>
              <a:chExt cx="1346400" cy="482760"/>
            </a:xfrm>
          </p:grpSpPr>
          <p:sp>
            <p:nvSpPr>
              <p:cNvPr id="70" name="CasellaDiTesto 212"/>
              <p:cNvSpPr/>
              <p:nvPr/>
            </p:nvSpPr>
            <p:spPr>
              <a:xfrm>
                <a:off x="4127040" y="690120"/>
                <a:ext cx="1329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000" spc="-1" strike="noStrike">
                    <a:solidFill>
                      <a:srgbClr val="000000"/>
                    </a:solidFill>
                    <a:latin typeface="Arial"/>
                  </a:rPr>
                  <a:t>●</a:t>
                </a: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   </a:t>
                </a: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pUSP2a</a:t>
                </a:r>
                <a:r>
                  <a:rPr b="0" lang="it-IT" sz="800" spc="-1" strike="noStrike" baseline="30000">
                    <a:solidFill>
                      <a:srgbClr val="000000"/>
                    </a:solidFill>
                    <a:latin typeface="Arial"/>
                  </a:rPr>
                  <a:t>WT </a:t>
                </a: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 + </a:t>
                </a:r>
                <a:r>
                  <a:rPr b="0" lang="it-IT" sz="800" spc="-1" strike="noStrike" u="sng">
                    <a:solidFill>
                      <a:srgbClr val="000000"/>
                    </a:solidFill>
                    <a:uFillTx/>
                    <a:latin typeface="Arial"/>
                  </a:rPr>
                  <a:t>miR-34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CasellaDiTesto 213"/>
              <p:cNvSpPr/>
              <p:nvPr/>
            </p:nvSpPr>
            <p:spPr>
              <a:xfrm>
                <a:off x="4110480" y="849600"/>
                <a:ext cx="1326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Wingdings 2"/>
                    <a:ea typeface="Wingdings 2"/>
                  </a:rPr>
                  <a:t></a:t>
                </a: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   </a:t>
                </a: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pUSP2a</a:t>
                </a:r>
                <a:r>
                  <a:rPr b="0" lang="it-IT" sz="800" spc="-1" strike="noStrike" baseline="30000">
                    <a:solidFill>
                      <a:srgbClr val="000000"/>
                    </a:solidFill>
                    <a:latin typeface="Arial"/>
                  </a:rPr>
                  <a:t>WT </a:t>
                </a: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 + miR-Ctr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CasellaDiTesto 211"/>
              <p:cNvSpPr/>
              <p:nvPr/>
            </p:nvSpPr>
            <p:spPr>
              <a:xfrm>
                <a:off x="4113000" y="582480"/>
                <a:ext cx="685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Wingdings"/>
                    <a:ea typeface="Wingdings"/>
                  </a:rPr>
                  <a:t></a:t>
                </a: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   </a:t>
                </a: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Vector 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3" name="CasellaDiTesto 28"/>
            <p:cNvSpPr/>
            <p:nvPr/>
          </p:nvSpPr>
          <p:spPr>
            <a:xfrm>
              <a:off x="3587040" y="688320"/>
              <a:ext cx="508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LNCa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4" name="Gruppo 1"/>
          <p:cNvGrpSpPr/>
          <p:nvPr/>
        </p:nvGrpSpPr>
        <p:grpSpPr>
          <a:xfrm>
            <a:off x="845280" y="4462560"/>
            <a:ext cx="3023280" cy="974520"/>
            <a:chOff x="845280" y="4462560"/>
            <a:chExt cx="3023280" cy="974520"/>
          </a:xfrm>
        </p:grpSpPr>
        <p:pic>
          <p:nvPicPr>
            <p:cNvPr id="75" name="Picture 36" descr=""/>
            <p:cNvPicPr/>
            <p:nvPr/>
          </p:nvPicPr>
          <p:blipFill>
            <a:blip r:embed="rId5"/>
            <a:stretch/>
          </p:blipFill>
          <p:spPr>
            <a:xfrm>
              <a:off x="2274840" y="4898880"/>
              <a:ext cx="763560" cy="142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6" name="Picture 38" descr=""/>
            <p:cNvPicPr/>
            <p:nvPr/>
          </p:nvPicPr>
          <p:blipFill>
            <a:blip r:embed="rId6">
              <a:grayscl/>
            </a:blip>
            <a:stretch/>
          </p:blipFill>
          <p:spPr>
            <a:xfrm>
              <a:off x="3152880" y="4898880"/>
              <a:ext cx="685800" cy="142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7" name="Picture 40" descr=""/>
            <p:cNvPicPr/>
            <p:nvPr/>
          </p:nvPicPr>
          <p:blipFill>
            <a:blip r:embed="rId7"/>
            <a:stretch/>
          </p:blipFill>
          <p:spPr>
            <a:xfrm>
              <a:off x="1444680" y="4898880"/>
              <a:ext cx="720720" cy="142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8" name="Picture 43" descr=""/>
            <p:cNvPicPr/>
            <p:nvPr/>
          </p:nvPicPr>
          <p:blipFill>
            <a:blip r:embed="rId8"/>
            <a:stretch/>
          </p:blipFill>
          <p:spPr>
            <a:xfrm>
              <a:off x="2287440" y="4662360"/>
              <a:ext cx="720720" cy="199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9" name="CasellaDiTesto 168"/>
            <p:cNvSpPr/>
            <p:nvPr/>
          </p:nvSpPr>
          <p:spPr>
            <a:xfrm>
              <a:off x="1410120" y="447048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CasellaDiTesto 169"/>
            <p:cNvSpPr/>
            <p:nvPr/>
          </p:nvSpPr>
          <p:spPr>
            <a:xfrm>
              <a:off x="1584720" y="447048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CasellaDiTesto 170"/>
            <p:cNvSpPr/>
            <p:nvPr/>
          </p:nvSpPr>
          <p:spPr>
            <a:xfrm>
              <a:off x="1764720" y="447048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CasellaDiTesto 171"/>
            <p:cNvSpPr/>
            <p:nvPr/>
          </p:nvSpPr>
          <p:spPr>
            <a:xfrm>
              <a:off x="1915920" y="447048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CasellaDiTesto 181"/>
            <p:cNvSpPr/>
            <p:nvPr/>
          </p:nvSpPr>
          <p:spPr>
            <a:xfrm>
              <a:off x="845280" y="4462560"/>
              <a:ext cx="636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CDDP (hrs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CasellaDiTesto 212"/>
            <p:cNvSpPr/>
            <p:nvPr/>
          </p:nvSpPr>
          <p:spPr>
            <a:xfrm>
              <a:off x="2301480" y="5022720"/>
              <a:ext cx="653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+ miR-34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CasellaDiTesto 213"/>
            <p:cNvSpPr/>
            <p:nvPr/>
          </p:nvSpPr>
          <p:spPr>
            <a:xfrm>
              <a:off x="1470600" y="5022720"/>
              <a:ext cx="619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+ miR-Ct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6" name="Gruppo 70"/>
            <p:cNvGrpSpPr/>
            <p:nvPr/>
          </p:nvGrpSpPr>
          <p:grpSpPr>
            <a:xfrm>
              <a:off x="2251440" y="4470480"/>
              <a:ext cx="779400" cy="200520"/>
              <a:chOff x="2251440" y="4470480"/>
              <a:chExt cx="779400" cy="200520"/>
            </a:xfrm>
          </p:grpSpPr>
          <p:sp>
            <p:nvSpPr>
              <p:cNvPr id="87" name="CasellaDiTesto 168"/>
              <p:cNvSpPr/>
              <p:nvPr/>
            </p:nvSpPr>
            <p:spPr>
              <a:xfrm>
                <a:off x="2251440" y="447048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CasellaDiTesto 169"/>
              <p:cNvSpPr/>
              <p:nvPr/>
            </p:nvSpPr>
            <p:spPr>
              <a:xfrm>
                <a:off x="2425320" y="447048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CasellaDiTesto 170"/>
              <p:cNvSpPr/>
              <p:nvPr/>
            </p:nvSpPr>
            <p:spPr>
              <a:xfrm>
                <a:off x="2594880" y="447048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CasellaDiTesto 171"/>
              <p:cNvSpPr/>
              <p:nvPr/>
            </p:nvSpPr>
            <p:spPr>
              <a:xfrm>
                <a:off x="2752560" y="4470480"/>
                <a:ext cx="2782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1" name="Gruppo 77"/>
            <p:cNvGrpSpPr/>
            <p:nvPr/>
          </p:nvGrpSpPr>
          <p:grpSpPr>
            <a:xfrm>
              <a:off x="3094200" y="4470480"/>
              <a:ext cx="774360" cy="200520"/>
              <a:chOff x="3094200" y="4470480"/>
              <a:chExt cx="774360" cy="200520"/>
            </a:xfrm>
          </p:grpSpPr>
          <p:sp>
            <p:nvSpPr>
              <p:cNvPr id="92" name="CasellaDiTesto 168"/>
              <p:cNvSpPr/>
              <p:nvPr/>
            </p:nvSpPr>
            <p:spPr>
              <a:xfrm>
                <a:off x="3094200" y="447048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CasellaDiTesto 169"/>
              <p:cNvSpPr/>
              <p:nvPr/>
            </p:nvSpPr>
            <p:spPr>
              <a:xfrm>
                <a:off x="3268080" y="447048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CasellaDiTesto 170"/>
              <p:cNvSpPr/>
              <p:nvPr/>
            </p:nvSpPr>
            <p:spPr>
              <a:xfrm>
                <a:off x="3437640" y="447048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CasellaDiTesto 171"/>
              <p:cNvSpPr/>
              <p:nvPr/>
            </p:nvSpPr>
            <p:spPr>
              <a:xfrm>
                <a:off x="3590280" y="4470480"/>
                <a:ext cx="2782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6" name="CasellaDiTesto 212"/>
            <p:cNvSpPr/>
            <p:nvPr/>
          </p:nvSpPr>
          <p:spPr>
            <a:xfrm>
              <a:off x="2142720" y="5221440"/>
              <a:ext cx="1037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LNCaP_pUSP2a</a:t>
              </a:r>
              <a:r>
                <a:rPr b="0" lang="it-IT" sz="800" spc="-1" strike="noStrike" baseline="30000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CasellaDiTesto 212"/>
            <p:cNvSpPr/>
            <p:nvPr/>
          </p:nvSpPr>
          <p:spPr>
            <a:xfrm>
              <a:off x="3160080" y="5022720"/>
              <a:ext cx="64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+ miR-34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Connettore 1 2"/>
            <p:cNvSpPr/>
            <p:nvPr/>
          </p:nvSpPr>
          <p:spPr>
            <a:xfrm>
              <a:off x="1452600" y="5224680"/>
              <a:ext cx="23796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CasellaDiTesto 4"/>
            <p:cNvSpPr/>
            <p:nvPr/>
          </p:nvSpPr>
          <p:spPr>
            <a:xfrm>
              <a:off x="1096200" y="4687920"/>
              <a:ext cx="3848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600" spc="-1" strike="noStrike">
                  <a:solidFill>
                    <a:srgbClr val="000000"/>
                  </a:solidFill>
                  <a:latin typeface="Arial"/>
                </a:rPr>
                <a:t>c-Myc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CasellaDiTesto 86"/>
            <p:cNvSpPr/>
            <p:nvPr/>
          </p:nvSpPr>
          <p:spPr>
            <a:xfrm>
              <a:off x="1071720" y="4838760"/>
              <a:ext cx="4093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6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0" lang="it-IT" sz="600" spc="-1" strike="noStrike">
                  <a:solidFill>
                    <a:srgbClr val="000000"/>
                  </a:solidFill>
                  <a:latin typeface="Arial"/>
                </a:rPr>
                <a:t>-act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1" name="Picture 48" descr=""/>
            <p:cNvPicPr/>
            <p:nvPr/>
          </p:nvPicPr>
          <p:blipFill>
            <a:blip r:embed="rId9"/>
            <a:stretch/>
          </p:blipFill>
          <p:spPr>
            <a:xfrm>
              <a:off x="1444680" y="4640040"/>
              <a:ext cx="720720" cy="242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2" name="Picture 64" descr=""/>
            <p:cNvPicPr/>
            <p:nvPr/>
          </p:nvPicPr>
          <p:blipFill>
            <a:blip r:embed="rId10"/>
            <a:stretch/>
          </p:blipFill>
          <p:spPr>
            <a:xfrm>
              <a:off x="3139920" y="4660920"/>
              <a:ext cx="720720" cy="20160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5-17T12:32:32Z</dcterms:created>
  <dc:creator>Barbara</dc:creator>
  <dc:description/>
  <dc:language>en-US</dc:language>
  <cp:lastModifiedBy>BarbaraB</cp:lastModifiedBy>
  <dcterms:modified xsi:type="dcterms:W3CDTF">2013-06-12T11:54:32Z</dcterms:modified>
  <cp:revision>46</cp:revision>
  <dc:subject/>
  <dc:title>Diapositiva 1</dc:title>
</cp:coreProperties>
</file>